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letter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814" autoAdjust="0"/>
  </p:normalViewPr>
  <p:slideViewPr>
    <p:cSldViewPr>
      <p:cViewPr varScale="1">
        <p:scale>
          <a:sx n="86" d="100"/>
          <a:sy n="86" d="100"/>
        </p:scale>
        <p:origin x="3186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137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188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457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969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3936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4666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885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862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5350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178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8114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506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28600" y="68580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197697" y="68580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021735" y="6858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9144551"/>
              </p:ext>
            </p:extLst>
          </p:nvPr>
        </p:nvGraphicFramePr>
        <p:xfrm>
          <a:off x="3299296" y="896442"/>
          <a:ext cx="1484313" cy="2076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78" name="SPW 13.0 Graph" r:id="rId3" imgW="3049450" imgH="4264231" progId="SigmaPlotGraphicObject.12">
                  <p:embed/>
                </p:oleObj>
              </mc:Choice>
              <mc:Fallback>
                <p:oleObj name="SPW 13.0 Graph" r:id="rId3" imgW="3049450" imgH="4264231" progId="SigmaPlotGraphicObject.12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99296" y="896442"/>
                        <a:ext cx="1484313" cy="20764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7020270"/>
              </p:ext>
            </p:extLst>
          </p:nvPr>
        </p:nvGraphicFramePr>
        <p:xfrm>
          <a:off x="5088409" y="886917"/>
          <a:ext cx="1565275" cy="2076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79" name="SPW 13.0 Graph" r:id="rId5" imgW="3194473" imgH="4235078" progId="SigmaPlotGraphicObject.12">
                  <p:embed/>
                </p:oleObj>
              </mc:Choice>
              <mc:Fallback>
                <p:oleObj name="SPW 13.0 Graph" r:id="rId5" imgW="3194473" imgH="4235078" progId="SigmaPlotGraphicObject.12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088409" y="886917"/>
                        <a:ext cx="1565275" cy="20764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41373181"/>
              </p:ext>
            </p:extLst>
          </p:nvPr>
        </p:nvGraphicFramePr>
        <p:xfrm>
          <a:off x="329084" y="3125292"/>
          <a:ext cx="2743200" cy="25431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80" name="SPW 13.0 Graph" r:id="rId7" imgW="5355388" imgH="4963539" progId="SigmaPlotGraphicObject.12">
                  <p:embed/>
                </p:oleObj>
              </mc:Choice>
              <mc:Fallback>
                <p:oleObj name="SPW 13.0 Graph" r:id="rId7" imgW="5355388" imgH="4963539" progId="SigmaPlotGraphicObjec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29084" y="3125292"/>
                        <a:ext cx="2743200" cy="25431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4321039"/>
              </p:ext>
            </p:extLst>
          </p:nvPr>
        </p:nvGraphicFramePr>
        <p:xfrm>
          <a:off x="3256543" y="3116239"/>
          <a:ext cx="2743200" cy="25386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81" name="SPW 13.0 Graph" r:id="rId9" imgW="5364406" imgH="4963539" progId="SigmaPlotGraphicObject.12">
                  <p:embed/>
                </p:oleObj>
              </mc:Choice>
              <mc:Fallback>
                <p:oleObj name="SPW 13.0 Graph" r:id="rId9" imgW="5364406" imgH="4963539" progId="SigmaPlotGraphicObjec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256543" y="3116239"/>
                        <a:ext cx="2743200" cy="25386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234778" y="315309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203875" y="315309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8790465"/>
              </p:ext>
            </p:extLst>
          </p:nvPr>
        </p:nvGraphicFramePr>
        <p:xfrm>
          <a:off x="276786" y="914400"/>
          <a:ext cx="2850889" cy="20116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82" name="SPW 13.0 Graph" r:id="rId11" imgW="5608276" imgH="3957946" progId="SigmaPlotGraphicObject.12">
                  <p:embed/>
                </p:oleObj>
              </mc:Choice>
              <mc:Fallback>
                <p:oleObj name="SPW 13.0 Graph" r:id="rId11" imgW="5608276" imgH="3957946" progId="SigmaPlotGraphicObjec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76786" y="914400"/>
                        <a:ext cx="2850889" cy="20116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721197" y="5486400"/>
            <a:ext cx="5527203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 Fig. Adipose-specific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reductions in ATX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xpression. 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elative gene expression in different tissues in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dark bars) an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Adipoq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Δ (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pen bars) male mice (n = 5-6 ) . B.) ATX protein expression in subcutaneous and visceral fat.  C.) Plasma ATX activity (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ol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min/ml) in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dark bars) and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ipoq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l-G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Δ 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pen bars) male mice (n = 8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. D. PPAR gene expression in subcutaneous adipose and (E) visceral adipose from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dark bars) an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Adipoq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Δ (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pen bars) male mice (n =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3). 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30957782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5</TotalTime>
  <Words>115</Words>
  <Application>Microsoft Office PowerPoint</Application>
  <PresentationFormat>Letter Paper (8.5x11 in)</PresentationFormat>
  <Paragraphs>6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Office Theme</vt:lpstr>
      <vt:lpstr>SPW 13.0 Graph</vt:lpstr>
      <vt:lpstr>PowerPoint Presentation</vt:lpstr>
    </vt:vector>
  </TitlesOfParts>
  <Company>University of Kentuck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myth, Susan</dc:creator>
  <cp:lastModifiedBy>McMullen, Colleen</cp:lastModifiedBy>
  <cp:revision>16</cp:revision>
  <cp:lastPrinted>2018-10-21T18:40:01Z</cp:lastPrinted>
  <dcterms:created xsi:type="dcterms:W3CDTF">2018-10-08T19:40:09Z</dcterms:created>
  <dcterms:modified xsi:type="dcterms:W3CDTF">2018-11-15T15:36:52Z</dcterms:modified>
</cp:coreProperties>
</file>